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0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72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54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50" d="100"/>
        <a:sy n="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25CD-3761-44C9-89FD-B9189931938E}" type="datetimeFigureOut">
              <a:rPr lang="it-IT" smtClean="0"/>
              <a:t>07/12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E0F5-8442-47F6-98EB-393DC2CEE3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21707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25CD-3761-44C9-89FD-B9189931938E}" type="datetimeFigureOut">
              <a:rPr lang="it-IT" smtClean="0"/>
              <a:t>07/12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E0F5-8442-47F6-98EB-393DC2CEE3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07543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25CD-3761-44C9-89FD-B9189931938E}" type="datetimeFigureOut">
              <a:rPr lang="it-IT" smtClean="0"/>
              <a:t>07/12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E0F5-8442-47F6-98EB-393DC2CEE3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91427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25CD-3761-44C9-89FD-B9189931938E}" type="datetimeFigureOut">
              <a:rPr lang="it-IT" smtClean="0"/>
              <a:t>07/12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E0F5-8442-47F6-98EB-393DC2CEE3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78722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25CD-3761-44C9-89FD-B9189931938E}" type="datetimeFigureOut">
              <a:rPr lang="it-IT" smtClean="0"/>
              <a:t>07/12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E0F5-8442-47F6-98EB-393DC2CEE3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9576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25CD-3761-44C9-89FD-B9189931938E}" type="datetimeFigureOut">
              <a:rPr lang="it-IT" smtClean="0"/>
              <a:t>07/12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E0F5-8442-47F6-98EB-393DC2CEE3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10099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25CD-3761-44C9-89FD-B9189931938E}" type="datetimeFigureOut">
              <a:rPr lang="it-IT" smtClean="0"/>
              <a:t>07/12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E0F5-8442-47F6-98EB-393DC2CEE3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708263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25CD-3761-44C9-89FD-B9189931938E}" type="datetimeFigureOut">
              <a:rPr lang="it-IT" smtClean="0"/>
              <a:t>07/12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E0F5-8442-47F6-98EB-393DC2CEE3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4148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25CD-3761-44C9-89FD-B9189931938E}" type="datetimeFigureOut">
              <a:rPr lang="it-IT" smtClean="0"/>
              <a:t>07/12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E0F5-8442-47F6-98EB-393DC2CEE3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331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25CD-3761-44C9-89FD-B9189931938E}" type="datetimeFigureOut">
              <a:rPr lang="it-IT" smtClean="0"/>
              <a:t>07/12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E0F5-8442-47F6-98EB-393DC2CEE3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17178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9525CD-3761-44C9-89FD-B9189931938E}" type="datetimeFigureOut">
              <a:rPr lang="it-IT" smtClean="0"/>
              <a:t>07/12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BE0F5-8442-47F6-98EB-393DC2CEE3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61474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9525CD-3761-44C9-89FD-B9189931938E}" type="datetimeFigureOut">
              <a:rPr lang="it-IT" smtClean="0"/>
              <a:t>07/12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FBE0F5-8442-47F6-98EB-393DC2CEE39F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831109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asellaDiTesto 9"/>
          <p:cNvSpPr txBox="1"/>
          <p:nvPr/>
        </p:nvSpPr>
        <p:spPr>
          <a:xfrm>
            <a:off x="1002257" y="3623012"/>
            <a:ext cx="10432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Ms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Y 10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3978963" y="3647244"/>
            <a:ext cx="10432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Ms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Y 13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7001858" y="3654103"/>
            <a:ext cx="10432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Ms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Y 21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10090059" y="3636666"/>
            <a:ext cx="10432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Ms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AY 25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Immagine 13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447102" y="549612"/>
            <a:ext cx="4269959" cy="2936450"/>
          </a:xfrm>
          <a:prstGeom prst="rect">
            <a:avLst/>
          </a:prstGeom>
          <a:ln w="6350">
            <a:noFill/>
          </a:ln>
        </p:spPr>
      </p:pic>
      <p:pic>
        <p:nvPicPr>
          <p:cNvPr id="15" name="Immagine 14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6117956" y="549612"/>
            <a:ext cx="4269959" cy="2936450"/>
          </a:xfrm>
          <a:prstGeom prst="rect">
            <a:avLst/>
          </a:prstGeom>
          <a:ln w="6350">
            <a:noFill/>
          </a:ln>
        </p:spPr>
      </p:pic>
      <p:sp>
        <p:nvSpPr>
          <p:cNvPr id="18" name="CasellaDiTesto 17"/>
          <p:cNvSpPr txBox="1"/>
          <p:nvPr/>
        </p:nvSpPr>
        <p:spPr>
          <a:xfrm>
            <a:off x="2376501" y="249930"/>
            <a:ext cx="24865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PSCs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ltured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ver a </a:t>
            </a:r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eder-layer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CasellaDiTesto 18"/>
          <p:cNvSpPr txBox="1"/>
          <p:nvPr/>
        </p:nvSpPr>
        <p:spPr>
          <a:xfrm>
            <a:off x="6791971" y="249929"/>
            <a:ext cx="28440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PSCs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ltured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eeder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free </a:t>
            </a:r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ditions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" name="Immagine 1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560" y="3931102"/>
            <a:ext cx="2933700" cy="2252663"/>
          </a:xfrm>
          <a:prstGeom prst="rect">
            <a:avLst/>
          </a:prstGeom>
        </p:spPr>
      </p:pic>
      <p:pic>
        <p:nvPicPr>
          <p:cNvPr id="21" name="Immagine 2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78360" y="3924243"/>
            <a:ext cx="2933700" cy="2252664"/>
          </a:xfrm>
          <a:prstGeom prst="rect">
            <a:avLst/>
          </a:prstGeom>
        </p:spPr>
      </p:pic>
      <p:pic>
        <p:nvPicPr>
          <p:cNvPr id="23" name="Immagine 2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56657" y="3927672"/>
            <a:ext cx="2933700" cy="2249235"/>
          </a:xfrm>
          <a:prstGeom prst="rect">
            <a:avLst/>
          </a:prstGeom>
        </p:spPr>
      </p:pic>
      <p:pic>
        <p:nvPicPr>
          <p:cNvPr id="24" name="Immagine 2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104658" y="3927672"/>
            <a:ext cx="2933700" cy="22492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53307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81</TotalTime>
  <Words>22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essandra Bolotta</dc:creator>
  <cp:lastModifiedBy>Provvidenza Maria Abruzzo</cp:lastModifiedBy>
  <cp:revision>171</cp:revision>
  <dcterms:created xsi:type="dcterms:W3CDTF">2018-04-12T11:10:49Z</dcterms:created>
  <dcterms:modified xsi:type="dcterms:W3CDTF">2018-12-07T08:26:05Z</dcterms:modified>
</cp:coreProperties>
</file>